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4" r:id="rId2"/>
  </p:sldIdLst>
  <p:sldSz cx="6480175" cy="8999538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A9A9"/>
    <a:srgbClr val="CAC8C8"/>
    <a:srgbClr val="DCDADA"/>
    <a:srgbClr val="E1DFDF"/>
    <a:srgbClr val="CE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49" autoAdjust="0"/>
    <p:restoredTop sz="92383" autoAdjust="0"/>
  </p:normalViewPr>
  <p:slideViewPr>
    <p:cSldViewPr snapToGrid="0">
      <p:cViewPr>
        <p:scale>
          <a:sx n="125" d="100"/>
          <a:sy n="125" d="100"/>
        </p:scale>
        <p:origin x="2652" y="-16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D26D49-6D75-4625-B197-77F31D63B0E7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1241425"/>
            <a:ext cx="24098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B8D57-DE94-4AFA-B20B-8668DBE2A06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6690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9432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334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5803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4775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040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4471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8910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6892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712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789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8570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2686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42342" y="991333"/>
            <a:ext cx="5508000" cy="2664000"/>
          </a:xfrm>
          <a:prstGeom prst="rect">
            <a:avLst/>
          </a:prstGeom>
        </p:spPr>
      </p:pic>
      <p:pic>
        <p:nvPicPr>
          <p:cNvPr id="4" name="Immagine 3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42342" y="4802145"/>
            <a:ext cx="5823734" cy="2664000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529939" y="7877668"/>
            <a:ext cx="537006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  <a:tabLst>
                <a:tab pos="2400300" algn="l"/>
              </a:tabLst>
            </a:pPr>
            <a:r>
              <a:rPr lang="en-US" sz="800" b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igure S1. 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ime </a:t>
            </a:r>
            <a:r>
              <a:rPr lang="it-IT" sz="8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ints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it-IT" sz="8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rological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rameters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zed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APACHE (A) and </a:t>
            </a:r>
            <a:r>
              <a:rPr lang="it-IT" sz="8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DAt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ients</a:t>
            </a:r>
            <a:r>
              <a:rPr lang="it-IT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B). </a:t>
            </a:r>
            <a:endParaRPr lang="it-IT" sz="8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E836F072-B3B5-43D6-AE20-FDD7D0560AB3}"/>
              </a:ext>
            </a:extLst>
          </p:cNvPr>
          <p:cNvSpPr txBox="1"/>
          <p:nvPr/>
        </p:nvSpPr>
        <p:spPr>
          <a:xfrm>
            <a:off x="529939" y="251996"/>
            <a:ext cx="574402" cy="2397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58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DFA416CE-75B8-4F9B-9CE1-5FEA05248600}"/>
              </a:ext>
            </a:extLst>
          </p:cNvPr>
          <p:cNvSpPr txBox="1"/>
          <p:nvPr/>
        </p:nvSpPr>
        <p:spPr>
          <a:xfrm>
            <a:off x="563113" y="4414769"/>
            <a:ext cx="574402" cy="2397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5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201165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7</TotalTime>
  <Words>23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sana Scutari</dc:creator>
  <cp:lastModifiedBy>MDPI-52</cp:lastModifiedBy>
  <cp:revision>88</cp:revision>
  <dcterms:created xsi:type="dcterms:W3CDTF">2020-07-11T09:38:02Z</dcterms:created>
  <dcterms:modified xsi:type="dcterms:W3CDTF">2021-07-19T13:13:34Z</dcterms:modified>
</cp:coreProperties>
</file>